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0" r:id="rId3"/>
    <p:sldId id="261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011" autoAdjust="0"/>
    <p:restoredTop sz="94660"/>
  </p:normalViewPr>
  <p:slideViewPr>
    <p:cSldViewPr snapToGrid="0">
      <p:cViewPr varScale="1">
        <p:scale>
          <a:sx n="82" d="100"/>
          <a:sy n="82" d="100"/>
        </p:scale>
        <p:origin x="67" y="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809EA-1D37-46BA-9E1C-C4CB4DC35499}" type="datetimeFigureOut">
              <a:rPr lang="en-NZ" smtClean="0"/>
              <a:t>8/08/2019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11340A-CD4E-42F6-AE7E-82825ACBAC40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8990900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809EA-1D37-46BA-9E1C-C4CB4DC35499}" type="datetimeFigureOut">
              <a:rPr lang="en-NZ" smtClean="0"/>
              <a:t>8/08/2019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11340A-CD4E-42F6-AE7E-82825ACBAC40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7835340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809EA-1D37-46BA-9E1C-C4CB4DC35499}" type="datetimeFigureOut">
              <a:rPr lang="en-NZ" smtClean="0"/>
              <a:t>8/08/2019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11340A-CD4E-42F6-AE7E-82825ACBAC40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6390725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809EA-1D37-46BA-9E1C-C4CB4DC35499}" type="datetimeFigureOut">
              <a:rPr lang="en-NZ" smtClean="0"/>
              <a:t>8/08/2019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11340A-CD4E-42F6-AE7E-82825ACBAC40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0989407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809EA-1D37-46BA-9E1C-C4CB4DC35499}" type="datetimeFigureOut">
              <a:rPr lang="en-NZ" smtClean="0"/>
              <a:t>8/08/2019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11340A-CD4E-42F6-AE7E-82825ACBAC40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7852887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809EA-1D37-46BA-9E1C-C4CB4DC35499}" type="datetimeFigureOut">
              <a:rPr lang="en-NZ" smtClean="0"/>
              <a:t>8/08/2019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11340A-CD4E-42F6-AE7E-82825ACBAC40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409037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809EA-1D37-46BA-9E1C-C4CB4DC35499}" type="datetimeFigureOut">
              <a:rPr lang="en-NZ" smtClean="0"/>
              <a:t>8/08/2019</a:t>
            </a:fld>
            <a:endParaRPr lang="en-N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11340A-CD4E-42F6-AE7E-82825ACBAC40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9859575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809EA-1D37-46BA-9E1C-C4CB4DC35499}" type="datetimeFigureOut">
              <a:rPr lang="en-NZ" smtClean="0"/>
              <a:t>8/08/2019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11340A-CD4E-42F6-AE7E-82825ACBAC40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8818469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809EA-1D37-46BA-9E1C-C4CB4DC35499}" type="datetimeFigureOut">
              <a:rPr lang="en-NZ" smtClean="0"/>
              <a:t>8/08/2019</a:t>
            </a:fld>
            <a:endParaRPr lang="en-N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11340A-CD4E-42F6-AE7E-82825ACBAC40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6635495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809EA-1D37-46BA-9E1C-C4CB4DC35499}" type="datetimeFigureOut">
              <a:rPr lang="en-NZ" smtClean="0"/>
              <a:t>8/08/2019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11340A-CD4E-42F6-AE7E-82825ACBAC40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3478187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809EA-1D37-46BA-9E1C-C4CB4DC35499}" type="datetimeFigureOut">
              <a:rPr lang="en-NZ" smtClean="0"/>
              <a:t>8/08/2019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11340A-CD4E-42F6-AE7E-82825ACBAC40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593067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6809EA-1D37-46BA-9E1C-C4CB4DC35499}" type="datetimeFigureOut">
              <a:rPr lang="en-NZ" smtClean="0"/>
              <a:t>8/08/2019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11340A-CD4E-42F6-AE7E-82825ACBAC40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5000249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NZ" dirty="0"/>
              <a:t>Supplementary Figure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NZ" dirty="0"/>
              <a:t>Legends: </a:t>
            </a:r>
          </a:p>
          <a:p>
            <a:r>
              <a:rPr lang="en-NZ" dirty="0"/>
              <a:t>Figure S1 Time series of raw data (blue) and fitted data (red) for all subject and all channels and all frequency bands for censored data. (Channel 1=</a:t>
            </a:r>
            <a:r>
              <a:rPr lang="en-NZ" dirty="0" err="1"/>
              <a:t>Fz</a:t>
            </a:r>
            <a:r>
              <a:rPr lang="en-NZ" dirty="0"/>
              <a:t>, 2=F3, 3=T3, 4=P3, 5=</a:t>
            </a:r>
            <a:r>
              <a:rPr lang="en-NZ" dirty="0" err="1"/>
              <a:t>Pz</a:t>
            </a:r>
            <a:r>
              <a:rPr lang="en-NZ" dirty="0"/>
              <a:t>)</a:t>
            </a:r>
          </a:p>
          <a:p>
            <a:endParaRPr lang="en-NZ" dirty="0"/>
          </a:p>
          <a:p>
            <a:r>
              <a:rPr lang="en-NZ" dirty="0"/>
              <a:t>Figure S2. Model fits for all subject and all channels and all frequency bands for the censored data. (Channel 1=</a:t>
            </a:r>
            <a:r>
              <a:rPr lang="en-NZ" dirty="0" err="1"/>
              <a:t>Fz</a:t>
            </a:r>
            <a:r>
              <a:rPr lang="en-NZ" dirty="0"/>
              <a:t>, 2=F3, 3=T3, 4=P3, 5=</a:t>
            </a:r>
            <a:r>
              <a:rPr lang="en-NZ" dirty="0" err="1"/>
              <a:t>Pz</a:t>
            </a:r>
            <a:r>
              <a:rPr lang="en-NZ" dirty="0"/>
              <a:t>)</a:t>
            </a:r>
          </a:p>
          <a:p>
            <a:endParaRPr lang="en-NZ" dirty="0"/>
          </a:p>
        </p:txBody>
      </p:sp>
    </p:spTree>
    <p:extLst>
      <p:ext uri="{BB962C8B-B14F-4D97-AF65-F5344CB8AC3E}">
        <p14:creationId xmlns:p14="http://schemas.microsoft.com/office/powerpoint/2010/main" val="14237015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148076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81125" y="0"/>
            <a:ext cx="942975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350999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3</TotalTime>
  <Words>98</Words>
  <Application>Microsoft Office PowerPoint</Application>
  <PresentationFormat>Widescreen</PresentationFormat>
  <Paragraphs>5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Supplementary Figures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mie Sleigh</dc:creator>
  <cp:lastModifiedBy>Newman, Catherine (ELS-EXE)</cp:lastModifiedBy>
  <cp:revision>6</cp:revision>
  <dcterms:created xsi:type="dcterms:W3CDTF">2019-03-22T04:19:56Z</dcterms:created>
  <dcterms:modified xsi:type="dcterms:W3CDTF">2019-08-08T11:00:44Z</dcterms:modified>
</cp:coreProperties>
</file>